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2056"/>
    <p:restoredTop sz="94626"/>
  </p:normalViewPr>
  <p:slideViewPr>
    <p:cSldViewPr snapToGrid="0">
      <p:cViewPr>
        <p:scale>
          <a:sx n="66" d="100"/>
          <a:sy n="66" d="100"/>
        </p:scale>
        <p:origin x="2550" y="9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keiichihiramoto\Desktop\Melanoma-Momordica\&#29983;&#12486;&#12441;&#12540;&#12479;\momo-melanoma-supp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 w="285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535-7D49-B620-20177D3BFC6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D535-7D49-B620-20177D3BFC62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D535-7D49-B620-20177D3BFC62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/>
              </a:solidFill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D535-7D49-B620-20177D3BFC62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A$9:$D$9</c:f>
                <c:numCache>
                  <c:formatCode>General</c:formatCode>
                  <c:ptCount val="4"/>
                  <c:pt idx="0">
                    <c:v>16.666133324799727</c:v>
                  </c:pt>
                  <c:pt idx="1">
                    <c:v>20.143485299222675</c:v>
                  </c:pt>
                  <c:pt idx="2">
                    <c:v>95.277279558140194</c:v>
                  </c:pt>
                  <c:pt idx="3">
                    <c:v>46.688756676527596</c:v>
                  </c:pt>
                </c:numCache>
              </c:numRef>
            </c:plus>
            <c:minus>
              <c:numRef>
                <c:f>Sheet1!$A$9:$D$9</c:f>
                <c:numCache>
                  <c:formatCode>General</c:formatCode>
                  <c:ptCount val="4"/>
                  <c:pt idx="0">
                    <c:v>16.666133324799727</c:v>
                  </c:pt>
                  <c:pt idx="1">
                    <c:v>20.143485299222675</c:v>
                  </c:pt>
                  <c:pt idx="2">
                    <c:v>95.277279558140194</c:v>
                  </c:pt>
                  <c:pt idx="3">
                    <c:v>46.688756676527596</c:v>
                  </c:pt>
                </c:numCache>
              </c:numRef>
            </c:minus>
            <c:spPr>
              <a:ln w="28575">
                <a:solidFill>
                  <a:schemeClr val="tx1"/>
                </a:solidFill>
              </a:ln>
            </c:spPr>
          </c:errBars>
          <c:val>
            <c:numRef>
              <c:f>Sheet1!$A$8:$D$8</c:f>
              <c:numCache>
                <c:formatCode>General</c:formatCode>
                <c:ptCount val="4"/>
                <c:pt idx="0">
                  <c:v>132.80000000000001</c:v>
                </c:pt>
                <c:pt idx="1">
                  <c:v>128.80000000000001</c:v>
                </c:pt>
                <c:pt idx="2">
                  <c:v>1063.2</c:v>
                </c:pt>
                <c:pt idx="3">
                  <c:v>377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535-7D49-B620-20177D3BFC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2133731096"/>
        <c:axId val="-2133741896"/>
      </c:barChart>
      <c:catAx>
        <c:axId val="-213373109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28575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-2133741896"/>
        <c:crosses val="autoZero"/>
        <c:auto val="1"/>
        <c:lblAlgn val="ctr"/>
        <c:lblOffset val="100"/>
        <c:noMultiLvlLbl val="0"/>
      </c:catAx>
      <c:valAx>
        <c:axId val="-2133741896"/>
        <c:scaling>
          <c:orientation val="minMax"/>
          <c:max val="150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28575">
            <a:solidFill>
              <a:schemeClr val="tx1"/>
            </a:solidFill>
          </a:ln>
        </c:spPr>
        <c:txPr>
          <a:bodyPr/>
          <a:lstStyle/>
          <a:p>
            <a:pPr>
              <a:defRPr lang="ja-JP" sz="1600" b="1" i="0">
                <a:latin typeface="Times New Roman"/>
              </a:defRPr>
            </a:pPr>
            <a:endParaRPr lang="en-US"/>
          </a:p>
        </c:txPr>
        <c:crossAx val="-2133731096"/>
        <c:crosses val="autoZero"/>
        <c:crossBetween val="between"/>
        <c:majorUnit val="300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7191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2493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832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2226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98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43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0545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780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5106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857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844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2D7F7-39BA-8341-ADB5-AEC01942AE35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9D2FA-4673-AF48-A9C2-81149DCBA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4733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2727088-B84E-2232-512F-1B94BA594979}"/>
              </a:ext>
            </a:extLst>
          </p:cNvPr>
          <p:cNvSpPr txBox="1"/>
          <p:nvPr/>
        </p:nvSpPr>
        <p:spPr>
          <a:xfrm>
            <a:off x="993913" y="233357"/>
            <a:ext cx="6705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Palatino Linotype" panose="02040502050505030304" pitchFamily="18" charset="0"/>
              </a:rPr>
              <a:t>Table S1. The composition of active </a:t>
            </a:r>
            <a:r>
              <a:rPr kumimoji="1" lang="en-US" altLang="ja-JP" b="1" dirty="0" err="1">
                <a:latin typeface="Palatino Linotype" panose="02040502050505030304" pitchFamily="18" charset="0"/>
              </a:rPr>
              <a:t>ingredience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in the MC extracts was determined by high-performance liquid chromatography (Vitamins A and C were measured using commercially kits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）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C3AE33E-6856-481C-DF0F-2D3986FB4DC7}"/>
              </a:ext>
            </a:extLst>
          </p:cNvPr>
          <p:cNvSpPr txBox="1"/>
          <p:nvPr/>
        </p:nvSpPr>
        <p:spPr>
          <a:xfrm>
            <a:off x="1073426" y="1577009"/>
            <a:ext cx="4788490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Palatino Linotype" panose="02040502050505030304" pitchFamily="18" charset="0"/>
              </a:rPr>
              <a:t>Vicine        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　　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            5 – 8 mg</a:t>
            </a:r>
          </a:p>
          <a:p>
            <a:r>
              <a:rPr kumimoji="1" lang="en-US" altLang="ja-JP" b="1" dirty="0" err="1">
                <a:latin typeface="Palatino Linotype" panose="02040502050505030304" pitchFamily="18" charset="0"/>
              </a:rPr>
              <a:t>Momordicin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　　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20 – 25 mg</a:t>
            </a:r>
          </a:p>
          <a:p>
            <a:r>
              <a:rPr kumimoji="1" lang="en-US" altLang="ja-JP" b="1" dirty="0" err="1">
                <a:latin typeface="Palatino Linotype" panose="02040502050505030304" pitchFamily="18" charset="0"/>
              </a:rPr>
              <a:t>Charntia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   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　　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  15 – 18 mg              </a:t>
            </a:r>
          </a:p>
          <a:p>
            <a:r>
              <a:rPr kumimoji="1" lang="en-US" altLang="ja-JP" b="1" dirty="0" err="1">
                <a:latin typeface="Palatino Linotype" panose="02040502050505030304" pitchFamily="18" charset="0"/>
              </a:rPr>
              <a:t>Momordin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　　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    3 – 6 mg</a:t>
            </a:r>
          </a:p>
          <a:p>
            <a:r>
              <a:rPr kumimoji="1" lang="en-US" altLang="ja-JP" b="1" dirty="0">
                <a:latin typeface="Palatino Linotype" panose="02040502050505030304" pitchFamily="18" charset="0"/>
              </a:rPr>
              <a:t>Cucurbitacin     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　　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  16 – 18 mg</a:t>
            </a:r>
          </a:p>
          <a:p>
            <a:r>
              <a:rPr kumimoji="1" lang="en-US" altLang="ja-JP" b="1" dirty="0">
                <a:latin typeface="Palatino Linotype" panose="02040502050505030304" pitchFamily="18" charset="0"/>
              </a:rPr>
              <a:t>Alkaloid             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　　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  50 – 56 mg</a:t>
            </a:r>
          </a:p>
          <a:p>
            <a:r>
              <a:rPr kumimoji="1" lang="en-US" altLang="ja-JP" b="1" dirty="0">
                <a:latin typeface="Palatino Linotype" panose="02040502050505030304" pitchFamily="18" charset="0"/>
              </a:rPr>
              <a:t>Flavonoid           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　　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 60 – 70 mg</a:t>
            </a:r>
          </a:p>
          <a:p>
            <a:r>
              <a:rPr kumimoji="1" lang="en-US" altLang="ja-JP" b="1" dirty="0">
                <a:latin typeface="Palatino Linotype" panose="02040502050505030304" pitchFamily="18" charset="0"/>
              </a:rPr>
              <a:t>Vitamin A          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　　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     226 mg</a:t>
            </a:r>
          </a:p>
          <a:p>
            <a:r>
              <a:rPr kumimoji="1" lang="en-US" altLang="ja-JP" b="1" dirty="0">
                <a:latin typeface="Palatino Linotype" panose="02040502050505030304" pitchFamily="18" charset="0"/>
              </a:rPr>
              <a:t>Vitamin C.            </a:t>
            </a:r>
            <a:r>
              <a:rPr kumimoji="1" lang="ja-JP" altLang="en-US" b="1" dirty="0">
                <a:latin typeface="Palatino Linotype" panose="02040502050505030304" pitchFamily="18" charset="0"/>
              </a:rPr>
              <a:t>　　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           240 mg</a:t>
            </a:r>
          </a:p>
          <a:p>
            <a:endParaRPr kumimoji="1" lang="ja-JP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456FA3B-9C5A-5D33-4869-D280075EE688}"/>
              </a:ext>
            </a:extLst>
          </p:cNvPr>
          <p:cNvSpPr txBox="1"/>
          <p:nvPr/>
        </p:nvSpPr>
        <p:spPr>
          <a:xfrm>
            <a:off x="1076361" y="4326327"/>
            <a:ext cx="3159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" altLang="ja-JP" b="1" dirty="0">
                <a:latin typeface="Palatino Linotype" panose="02040502050505030304" pitchFamily="18" charset="0"/>
              </a:rPr>
              <a:t>Content in 100 g </a:t>
            </a:r>
            <a:r>
              <a:rPr kumimoji="1" lang="en" altLang="ja-JP" b="1">
                <a:latin typeface="Palatino Linotype" panose="02040502050505030304" pitchFamily="18" charset="0"/>
              </a:rPr>
              <a:t>MC extract.</a:t>
            </a:r>
            <a:endParaRPr kumimoji="1" lang="ja-JP" altLang="en-US" b="1">
              <a:latin typeface="Palatino Linotype" panose="02040502050505030304" pitchFamily="18" charset="0"/>
            </a:endParaRP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74EDFCCF-E589-5002-A86E-21D8C3AD8455}"/>
              </a:ext>
            </a:extLst>
          </p:cNvPr>
          <p:cNvCxnSpPr/>
          <p:nvPr/>
        </p:nvCxnSpPr>
        <p:spPr>
          <a:xfrm>
            <a:off x="1073426" y="1413659"/>
            <a:ext cx="641405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23D210A7-253C-D4EB-0657-D06C7014A785}"/>
              </a:ext>
            </a:extLst>
          </p:cNvPr>
          <p:cNvCxnSpPr/>
          <p:nvPr/>
        </p:nvCxnSpPr>
        <p:spPr>
          <a:xfrm>
            <a:off x="1139687" y="4296007"/>
            <a:ext cx="641405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A193A0F-78A8-065C-CAC8-3A472D8CD363}"/>
              </a:ext>
            </a:extLst>
          </p:cNvPr>
          <p:cNvSpPr txBox="1"/>
          <p:nvPr/>
        </p:nvSpPr>
        <p:spPr>
          <a:xfrm>
            <a:off x="1058798" y="4872282"/>
            <a:ext cx="8066567" cy="18158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substance for measurement</a:t>
            </a:r>
          </a:p>
          <a:p>
            <a:r>
              <a:rPr kumimoji="1"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cine: Merk-Aldrich</a:t>
            </a:r>
          </a:p>
          <a:p>
            <a:r>
              <a:rPr kumimoji="1" lang="en" altLang="ja-JP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mordicin</a:t>
            </a:r>
            <a:r>
              <a:rPr kumimoji="1"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ChemExpress</a:t>
            </a:r>
            <a:endParaRPr kumimoji="1"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rantia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aDex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.</a:t>
            </a:r>
          </a:p>
          <a:p>
            <a:r>
              <a:rPr kumimoji="1" lang="en-US" altLang="ja-JP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mordin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lleck Co.</a:t>
            </a:r>
          </a:p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kaloid: </a:t>
            </a:r>
            <a:r>
              <a:rPr lang="en" altLang="ja-JP" sz="1600" b="1" i="0" u="none" strike="noStrike" dirty="0" err="1"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icotine+morfine+kinine</a:t>
            </a:r>
            <a:r>
              <a:rPr lang="en" altLang="ja-JP" sz="1600" b="1" i="0" u="none" strike="noStrike" dirty="0"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FUJIFILM Wako</a:t>
            </a:r>
          </a:p>
          <a:p>
            <a:r>
              <a:rPr kumimoji="1" lang="en" altLang="ja-JP" sz="1600" b="1" dirty="0">
                <a:solidFill>
                  <a:srgbClr val="44444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vonoid: </a:t>
            </a:r>
            <a:r>
              <a:rPr lang="en" altLang="ja-JP" sz="1600" b="1" i="0" u="none" strike="noStrike" dirty="0" err="1"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oflavone</a:t>
            </a:r>
            <a:r>
              <a:rPr lang="en" altLang="ja-JP" sz="1600" b="1" dirty="0" err="1">
                <a:solidFill>
                  <a:srgbClr val="44444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" altLang="ja-JP" sz="1600" b="1" i="0" u="none" strike="noStrike" dirty="0" err="1"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urcumin</a:t>
            </a:r>
            <a:r>
              <a:rPr lang="en" altLang="ja-JP" sz="1600" b="1" dirty="0" err="1">
                <a:solidFill>
                  <a:srgbClr val="44444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" altLang="ja-JP" sz="1600" b="1" i="0" u="none" strike="noStrike" dirty="0" err="1"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quercetin</a:t>
            </a:r>
            <a:r>
              <a:rPr lang="en" altLang="ja-JP" sz="1600" b="1" dirty="0" err="1">
                <a:solidFill>
                  <a:srgbClr val="44444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" altLang="ja-JP" sz="1600" b="1" i="0" u="none" strike="noStrike" dirty="0" err="1"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atechin</a:t>
            </a:r>
            <a:r>
              <a:rPr lang="en" altLang="ja-JP" sz="1600" b="1" dirty="0" err="1">
                <a:solidFill>
                  <a:srgbClr val="44444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" altLang="ja-JP" sz="1600" b="1" i="0" u="none" strike="noStrike" dirty="0" err="1"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pigallocatechin</a:t>
            </a:r>
            <a:r>
              <a:rPr lang="en" altLang="ja-JP" sz="1600" b="1" i="0" u="none" strike="noStrike" dirty="0"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FUJIFILM Wako</a:t>
            </a:r>
            <a:endParaRPr kumimoji="1" lang="en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53893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7F950751-9817-E4AD-6C5F-AC3BDE8FB4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6228322" y="479556"/>
            <a:ext cx="2143218" cy="1613717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3BDC9856-5370-1EF7-EC63-873960DAC1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996365" y="486046"/>
            <a:ext cx="2143217" cy="161371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1006C37-9C41-F427-E797-CD8C41D381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4468831" y="479450"/>
            <a:ext cx="2143217" cy="1613716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57DE2DE-DC71-65C2-A1C3-568184DED8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5400000">
            <a:off x="2734483" y="486046"/>
            <a:ext cx="2143218" cy="1613717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B5545CD-877B-9716-A7F7-8F67ED3B9E78}"/>
              </a:ext>
            </a:extLst>
          </p:cNvPr>
          <p:cNvSpPr txBox="1"/>
          <p:nvPr/>
        </p:nvSpPr>
        <p:spPr>
          <a:xfrm>
            <a:off x="1542213" y="2300827"/>
            <a:ext cx="1033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"/>
                <a:cs typeface="Times"/>
              </a:rPr>
              <a:t>Control</a:t>
            </a:r>
            <a:endParaRPr kumimoji="1" lang="ja-JP" altLang="en-US" sz="2000" b="1" dirty="0">
              <a:latin typeface="Times"/>
              <a:cs typeface="Times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49784A5-2BC8-E5E4-F62D-2DCABC39C13B}"/>
              </a:ext>
            </a:extLst>
          </p:cNvPr>
          <p:cNvSpPr txBox="1"/>
          <p:nvPr/>
        </p:nvSpPr>
        <p:spPr>
          <a:xfrm>
            <a:off x="4916630" y="2297192"/>
            <a:ext cx="14878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"/>
                <a:cs typeface="Times"/>
              </a:rPr>
              <a:t>Melanoma</a:t>
            </a:r>
            <a:endParaRPr kumimoji="1" lang="ja-JP" altLang="en-US" sz="2000" b="1" dirty="0">
              <a:latin typeface="Times"/>
              <a:cs typeface="Time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E2424E6-6898-357B-904A-56E06DA37670}"/>
              </a:ext>
            </a:extLst>
          </p:cNvPr>
          <p:cNvSpPr txBox="1"/>
          <p:nvPr/>
        </p:nvSpPr>
        <p:spPr>
          <a:xfrm>
            <a:off x="6347298" y="2323386"/>
            <a:ext cx="270914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"/>
                <a:cs typeface="Times"/>
              </a:rPr>
              <a:t>Melanoma + MC extract</a:t>
            </a:r>
            <a:endParaRPr kumimoji="1" lang="ja-JP" altLang="en-US" sz="2000" b="1" dirty="0">
              <a:latin typeface="Times"/>
              <a:cs typeface="Times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50CE348-053A-CDBA-8BCE-459EF29372C0}"/>
              </a:ext>
            </a:extLst>
          </p:cNvPr>
          <p:cNvSpPr txBox="1"/>
          <p:nvPr/>
        </p:nvSpPr>
        <p:spPr>
          <a:xfrm>
            <a:off x="3125098" y="2297192"/>
            <a:ext cx="14878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"/>
                <a:cs typeface="Times"/>
              </a:rPr>
              <a:t>MC extract</a:t>
            </a:r>
            <a:endParaRPr kumimoji="1" lang="ja-JP" altLang="en-US" sz="2000" b="1" dirty="0">
              <a:latin typeface="Times"/>
              <a:cs typeface="Times"/>
            </a:endParaRPr>
          </a:p>
        </p:txBody>
      </p:sp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FB0A56F4-708F-09FB-87E9-7DEDB4337A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8609560"/>
              </p:ext>
            </p:extLst>
          </p:nvPr>
        </p:nvGraphicFramePr>
        <p:xfrm>
          <a:off x="2881449" y="3652956"/>
          <a:ext cx="3903557" cy="21432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9915B45-A7F9-F735-A430-94319C247A26}"/>
              </a:ext>
            </a:extLst>
          </p:cNvPr>
          <p:cNvSpPr txBox="1"/>
          <p:nvPr/>
        </p:nvSpPr>
        <p:spPr>
          <a:xfrm rot="16200000">
            <a:off x="1223939" y="4139430"/>
            <a:ext cx="27884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pa positive melanocyte/mm</a:t>
            </a:r>
            <a:r>
              <a:rPr kumimoji="1"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b="1" baseline="30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93CE53A-10ED-BE5D-265C-893D88145F0A}"/>
              </a:ext>
            </a:extLst>
          </p:cNvPr>
          <p:cNvSpPr txBox="1"/>
          <p:nvPr/>
        </p:nvSpPr>
        <p:spPr>
          <a:xfrm rot="16200000">
            <a:off x="3553617" y="4833275"/>
            <a:ext cx="9917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/>
                <a:cs typeface="Times"/>
              </a:rPr>
              <a:t>Control</a:t>
            </a:r>
            <a:endParaRPr kumimoji="1" lang="ja-JP" altLang="en-US" sz="1600" b="1" dirty="0">
              <a:latin typeface="Times"/>
              <a:cs typeface="Time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E55E39E-CB70-5454-92FB-3F1EDB0BD744}"/>
              </a:ext>
            </a:extLst>
          </p:cNvPr>
          <p:cNvSpPr txBox="1"/>
          <p:nvPr/>
        </p:nvSpPr>
        <p:spPr>
          <a:xfrm rot="16200000">
            <a:off x="4850972" y="4865858"/>
            <a:ext cx="11904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/>
                <a:cs typeface="Times"/>
              </a:rPr>
              <a:t>Melanoma</a:t>
            </a:r>
            <a:endParaRPr kumimoji="1" lang="ja-JP" altLang="en-US" sz="1600" b="1" dirty="0">
              <a:latin typeface="Times"/>
              <a:cs typeface="Times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144756E-28AD-7E46-C519-09D5AD9C4F57}"/>
              </a:ext>
            </a:extLst>
          </p:cNvPr>
          <p:cNvSpPr txBox="1"/>
          <p:nvPr/>
        </p:nvSpPr>
        <p:spPr>
          <a:xfrm rot="16200000">
            <a:off x="5684861" y="4326333"/>
            <a:ext cx="20824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/>
                <a:cs typeface="Times"/>
              </a:rPr>
              <a:t>Melanoma + MC extract</a:t>
            </a:r>
            <a:endParaRPr kumimoji="1" lang="ja-JP" altLang="en-US" sz="1600" b="1" dirty="0">
              <a:latin typeface="Times"/>
              <a:cs typeface="Times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A913D48-FF5E-DFB6-BA90-24A148F8DD02}"/>
              </a:ext>
            </a:extLst>
          </p:cNvPr>
          <p:cNvSpPr txBox="1"/>
          <p:nvPr/>
        </p:nvSpPr>
        <p:spPr>
          <a:xfrm rot="16200000">
            <a:off x="4258147" y="4751852"/>
            <a:ext cx="11904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/>
                <a:cs typeface="Times"/>
              </a:rPr>
              <a:t>MC extract</a:t>
            </a:r>
            <a:endParaRPr kumimoji="1" lang="ja-JP" altLang="en-US" sz="1600" b="1" dirty="0">
              <a:latin typeface="Times"/>
              <a:cs typeface="Times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C2CA21F9-FEDA-493F-D0A0-FD860A2A9D32}"/>
              </a:ext>
            </a:extLst>
          </p:cNvPr>
          <p:cNvCxnSpPr>
            <a:cxnSpLocks/>
          </p:cNvCxnSpPr>
          <p:nvPr/>
        </p:nvCxnSpPr>
        <p:spPr>
          <a:xfrm>
            <a:off x="4006577" y="3488450"/>
            <a:ext cx="15326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E08F6732-EDB7-D1C9-CA70-A23513FEFB17}"/>
              </a:ext>
            </a:extLst>
          </p:cNvPr>
          <p:cNvCxnSpPr>
            <a:cxnSpLocks/>
          </p:cNvCxnSpPr>
          <p:nvPr/>
        </p:nvCxnSpPr>
        <p:spPr>
          <a:xfrm>
            <a:off x="4509872" y="3152005"/>
            <a:ext cx="231879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DC7974F4-376A-B4F1-A39B-CDD1DA469C54}"/>
              </a:ext>
            </a:extLst>
          </p:cNvPr>
          <p:cNvCxnSpPr>
            <a:cxnSpLocks/>
          </p:cNvCxnSpPr>
          <p:nvPr/>
        </p:nvCxnSpPr>
        <p:spPr>
          <a:xfrm>
            <a:off x="4836171" y="3773066"/>
            <a:ext cx="13920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150AAC77-C2F7-719E-A8A2-D6D54CA6FA75}"/>
              </a:ext>
            </a:extLst>
          </p:cNvPr>
          <p:cNvCxnSpPr>
            <a:cxnSpLocks/>
          </p:cNvCxnSpPr>
          <p:nvPr/>
        </p:nvCxnSpPr>
        <p:spPr>
          <a:xfrm>
            <a:off x="4814715" y="4066750"/>
            <a:ext cx="59685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2103E070-E07D-D51D-3AE7-6DBF59605B45}"/>
              </a:ext>
            </a:extLst>
          </p:cNvPr>
          <p:cNvCxnSpPr>
            <a:cxnSpLocks/>
          </p:cNvCxnSpPr>
          <p:nvPr/>
        </p:nvCxnSpPr>
        <p:spPr>
          <a:xfrm>
            <a:off x="5563248" y="4066754"/>
            <a:ext cx="59685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0270B93-1E9A-4689-4784-2DDB77865A68}"/>
              </a:ext>
            </a:extLst>
          </p:cNvPr>
          <p:cNvSpPr txBox="1"/>
          <p:nvPr/>
        </p:nvSpPr>
        <p:spPr>
          <a:xfrm>
            <a:off x="4590038" y="3193035"/>
            <a:ext cx="534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74A70D7-6C20-5C69-5A7D-FE0C6EB14187}"/>
              </a:ext>
            </a:extLst>
          </p:cNvPr>
          <p:cNvSpPr txBox="1"/>
          <p:nvPr/>
        </p:nvSpPr>
        <p:spPr>
          <a:xfrm>
            <a:off x="5635223" y="3768666"/>
            <a:ext cx="627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A347F62-F022-FAB3-6D6E-5C69557E2C8F}"/>
              </a:ext>
            </a:extLst>
          </p:cNvPr>
          <p:cNvSpPr txBox="1"/>
          <p:nvPr/>
        </p:nvSpPr>
        <p:spPr>
          <a:xfrm>
            <a:off x="5423386" y="2852637"/>
            <a:ext cx="853090" cy="4710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53B1DF7-849D-8B8B-8F27-9E71F14F2F55}"/>
              </a:ext>
            </a:extLst>
          </p:cNvPr>
          <p:cNvSpPr txBox="1"/>
          <p:nvPr/>
        </p:nvSpPr>
        <p:spPr>
          <a:xfrm>
            <a:off x="4917589" y="3768661"/>
            <a:ext cx="5201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96857DD-BE08-60DD-94B8-71F636DDA976}"/>
              </a:ext>
            </a:extLst>
          </p:cNvPr>
          <p:cNvSpPr txBox="1"/>
          <p:nvPr/>
        </p:nvSpPr>
        <p:spPr>
          <a:xfrm>
            <a:off x="5205215" y="3469520"/>
            <a:ext cx="5847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0EAC4D4-E4BE-3494-7EA1-A0A3BB9D8BA4}"/>
              </a:ext>
            </a:extLst>
          </p:cNvPr>
          <p:cNvCxnSpPr>
            <a:cxnSpLocks/>
          </p:cNvCxnSpPr>
          <p:nvPr/>
        </p:nvCxnSpPr>
        <p:spPr>
          <a:xfrm>
            <a:off x="1366446" y="1967358"/>
            <a:ext cx="70900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50B6670-F6D5-21C5-11BB-31F76FF3B464}"/>
              </a:ext>
            </a:extLst>
          </p:cNvPr>
          <p:cNvSpPr txBox="1"/>
          <p:nvPr/>
        </p:nvSpPr>
        <p:spPr>
          <a:xfrm>
            <a:off x="1218787" y="1982958"/>
            <a:ext cx="10588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kumimoji="1" lang="en-US" altLang="ja-JP" b="1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A6928D6-9D35-80B8-015D-D53CAAF2FA21}"/>
              </a:ext>
            </a:extLst>
          </p:cNvPr>
          <p:cNvSpPr txBox="1"/>
          <p:nvPr/>
        </p:nvSpPr>
        <p:spPr>
          <a:xfrm>
            <a:off x="619964" y="5915783"/>
            <a:ext cx="826219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ffect of Momordica 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arantia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MC) extract treatment on infiltration </a:t>
            </a:r>
          </a:p>
          <a:p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proliferation of melanoma in the lungs.</a:t>
            </a:r>
            <a:r>
              <a:rPr lang="ja-JP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dministration of MC extract alone did </a:t>
            </a:r>
          </a:p>
          <a:p>
            <a:r>
              <a:rPr lang="en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t alter the expression of dopa-positive melanocytes.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**</a:t>
            </a:r>
            <a:r>
              <a:rPr lang="en-US" altLang="ja-JP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&lt; 0.01. Scale bar = 100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Symbol" pitchFamily="2" charset="2"/>
                <a:ea typeface="SimSun" panose="02010600030101010101" pitchFamily="2" charset="-122"/>
                <a:cs typeface="Times New Roman" panose="02020603050405020304" pitchFamily="18" charset="0"/>
              </a:rPr>
              <a:t>m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.</a:t>
            </a:r>
            <a:r>
              <a:rPr lang="ja-JP" altLang="ja-JP" dirty="0">
                <a:effectLst/>
              </a:rPr>
              <a:t>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7390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3</TotalTime>
  <Words>199</Words>
  <Application>Microsoft Office PowerPoint</Application>
  <PresentationFormat>On-screen Show (4:3)</PresentationFormat>
  <Paragraphs>3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Symbol</vt:lpstr>
      <vt:lpstr>Times</vt:lpstr>
      <vt:lpstr>Times New Roman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平本　恵一</dc:creator>
  <cp:lastModifiedBy>MDPI</cp:lastModifiedBy>
  <cp:revision>7</cp:revision>
  <dcterms:created xsi:type="dcterms:W3CDTF">2024-11-07T04:30:37Z</dcterms:created>
  <dcterms:modified xsi:type="dcterms:W3CDTF">2024-11-28T06:10:51Z</dcterms:modified>
</cp:coreProperties>
</file>